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2879725" cy="5399088"/>
  <p:notesSz cx="6858000" cy="9144000"/>
  <p:defaultTextStyle>
    <a:defPPr>
      <a:defRPr lang="it-IT"/>
    </a:defPPr>
    <a:lvl1pPr marL="0" algn="l" defTabSz="431963" rtl="0" eaLnBrk="1" latinLnBrk="0" hangingPunct="1">
      <a:defRPr sz="850" kern="1200">
        <a:solidFill>
          <a:schemeClr val="tx1"/>
        </a:solidFill>
        <a:latin typeface="+mn-lt"/>
        <a:ea typeface="+mn-ea"/>
        <a:cs typeface="+mn-cs"/>
      </a:defRPr>
    </a:lvl1pPr>
    <a:lvl2pPr marL="215981" algn="l" defTabSz="431963" rtl="0" eaLnBrk="1" latinLnBrk="0" hangingPunct="1">
      <a:defRPr sz="850" kern="1200">
        <a:solidFill>
          <a:schemeClr val="tx1"/>
        </a:solidFill>
        <a:latin typeface="+mn-lt"/>
        <a:ea typeface="+mn-ea"/>
        <a:cs typeface="+mn-cs"/>
      </a:defRPr>
    </a:lvl2pPr>
    <a:lvl3pPr marL="431963" algn="l" defTabSz="431963" rtl="0" eaLnBrk="1" latinLnBrk="0" hangingPunct="1">
      <a:defRPr sz="850" kern="1200">
        <a:solidFill>
          <a:schemeClr val="tx1"/>
        </a:solidFill>
        <a:latin typeface="+mn-lt"/>
        <a:ea typeface="+mn-ea"/>
        <a:cs typeface="+mn-cs"/>
      </a:defRPr>
    </a:lvl3pPr>
    <a:lvl4pPr marL="647944" algn="l" defTabSz="431963" rtl="0" eaLnBrk="1" latinLnBrk="0" hangingPunct="1">
      <a:defRPr sz="850" kern="1200">
        <a:solidFill>
          <a:schemeClr val="tx1"/>
        </a:solidFill>
        <a:latin typeface="+mn-lt"/>
        <a:ea typeface="+mn-ea"/>
        <a:cs typeface="+mn-cs"/>
      </a:defRPr>
    </a:lvl4pPr>
    <a:lvl5pPr marL="863925" algn="l" defTabSz="431963" rtl="0" eaLnBrk="1" latinLnBrk="0" hangingPunct="1">
      <a:defRPr sz="850" kern="1200">
        <a:solidFill>
          <a:schemeClr val="tx1"/>
        </a:solidFill>
        <a:latin typeface="+mn-lt"/>
        <a:ea typeface="+mn-ea"/>
        <a:cs typeface="+mn-cs"/>
      </a:defRPr>
    </a:lvl5pPr>
    <a:lvl6pPr marL="1079906" algn="l" defTabSz="431963" rtl="0" eaLnBrk="1" latinLnBrk="0" hangingPunct="1">
      <a:defRPr sz="850" kern="1200">
        <a:solidFill>
          <a:schemeClr val="tx1"/>
        </a:solidFill>
        <a:latin typeface="+mn-lt"/>
        <a:ea typeface="+mn-ea"/>
        <a:cs typeface="+mn-cs"/>
      </a:defRPr>
    </a:lvl6pPr>
    <a:lvl7pPr marL="1295888" algn="l" defTabSz="431963" rtl="0" eaLnBrk="1" latinLnBrk="0" hangingPunct="1">
      <a:defRPr sz="850" kern="1200">
        <a:solidFill>
          <a:schemeClr val="tx1"/>
        </a:solidFill>
        <a:latin typeface="+mn-lt"/>
        <a:ea typeface="+mn-ea"/>
        <a:cs typeface="+mn-cs"/>
      </a:defRPr>
    </a:lvl7pPr>
    <a:lvl8pPr marL="1511869" algn="l" defTabSz="431963" rtl="0" eaLnBrk="1" latinLnBrk="0" hangingPunct="1">
      <a:defRPr sz="850" kern="1200">
        <a:solidFill>
          <a:schemeClr val="tx1"/>
        </a:solidFill>
        <a:latin typeface="+mn-lt"/>
        <a:ea typeface="+mn-ea"/>
        <a:cs typeface="+mn-cs"/>
      </a:defRPr>
    </a:lvl8pPr>
    <a:lvl9pPr marL="1727850" algn="l" defTabSz="431963" rtl="0" eaLnBrk="1" latinLnBrk="0" hangingPunct="1">
      <a:defRPr sz="85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7"/>
    <p:restoredTop sz="94647"/>
  </p:normalViewPr>
  <p:slideViewPr>
    <p:cSldViewPr snapToGrid="0" snapToObjects="1">
      <p:cViewPr varScale="1">
        <p:scale>
          <a:sx n="191" d="100"/>
          <a:sy n="191" d="100"/>
        </p:scale>
        <p:origin x="35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5980" y="883601"/>
            <a:ext cx="2447766" cy="1879682"/>
          </a:xfrm>
        </p:spPr>
        <p:txBody>
          <a:bodyPr anchor="b"/>
          <a:lstStyle>
            <a:lvl1pPr algn="ctr">
              <a:defRPr sz="188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59966" y="2835772"/>
            <a:ext cx="2159794" cy="1303529"/>
          </a:xfrm>
        </p:spPr>
        <p:txBody>
          <a:bodyPr/>
          <a:lstStyle>
            <a:lvl1pPr marL="0" indent="0" algn="ctr">
              <a:buNone/>
              <a:defRPr sz="756"/>
            </a:lvl1pPr>
            <a:lvl2pPr marL="143972" indent="0" algn="ctr">
              <a:buNone/>
              <a:defRPr sz="630"/>
            </a:lvl2pPr>
            <a:lvl3pPr marL="287945" indent="0" algn="ctr">
              <a:buNone/>
              <a:defRPr sz="567"/>
            </a:lvl3pPr>
            <a:lvl4pPr marL="431917" indent="0" algn="ctr">
              <a:buNone/>
              <a:defRPr sz="504"/>
            </a:lvl4pPr>
            <a:lvl5pPr marL="575889" indent="0" algn="ctr">
              <a:buNone/>
              <a:defRPr sz="504"/>
            </a:lvl5pPr>
            <a:lvl6pPr marL="719861" indent="0" algn="ctr">
              <a:buNone/>
              <a:defRPr sz="504"/>
            </a:lvl6pPr>
            <a:lvl7pPr marL="863834" indent="0" algn="ctr">
              <a:buNone/>
              <a:defRPr sz="504"/>
            </a:lvl7pPr>
            <a:lvl8pPr marL="1007806" indent="0" algn="ctr">
              <a:buNone/>
              <a:defRPr sz="504"/>
            </a:lvl8pPr>
            <a:lvl9pPr marL="1151778" indent="0" algn="ctr">
              <a:buNone/>
              <a:defRPr sz="504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5063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81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0803" y="287451"/>
            <a:ext cx="620941" cy="457547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7981" y="287451"/>
            <a:ext cx="1826826" cy="457547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9603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7064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481" y="1346024"/>
            <a:ext cx="2483763" cy="2245870"/>
          </a:xfrm>
        </p:spPr>
        <p:txBody>
          <a:bodyPr anchor="b"/>
          <a:lstStyle>
            <a:lvl1pPr>
              <a:defRPr sz="188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481" y="3613141"/>
            <a:ext cx="2483763" cy="1181050"/>
          </a:xfrm>
        </p:spPr>
        <p:txBody>
          <a:bodyPr/>
          <a:lstStyle>
            <a:lvl1pPr marL="0" indent="0">
              <a:buNone/>
              <a:defRPr sz="756">
                <a:solidFill>
                  <a:schemeClr val="tx1"/>
                </a:solidFill>
              </a:defRPr>
            </a:lvl1pPr>
            <a:lvl2pPr marL="143972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2pPr>
            <a:lvl3pPr marL="287945" indent="0">
              <a:buNone/>
              <a:defRPr sz="567">
                <a:solidFill>
                  <a:schemeClr val="tx1">
                    <a:tint val="75000"/>
                  </a:schemeClr>
                </a:solidFill>
              </a:defRPr>
            </a:lvl3pPr>
            <a:lvl4pPr marL="431917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4pPr>
            <a:lvl5pPr marL="575889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5pPr>
            <a:lvl6pPr marL="719861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6pPr>
            <a:lvl7pPr marL="863834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7pPr>
            <a:lvl8pPr marL="1007806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8pPr>
            <a:lvl9pPr marL="1151778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9768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7981" y="1437257"/>
            <a:ext cx="1223883" cy="3425672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7861" y="1437257"/>
            <a:ext cx="1223883" cy="3425672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7799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56" y="287453"/>
            <a:ext cx="2483763" cy="1043574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57" y="1323527"/>
            <a:ext cx="1218258" cy="648640"/>
          </a:xfrm>
        </p:spPr>
        <p:txBody>
          <a:bodyPr anchor="b"/>
          <a:lstStyle>
            <a:lvl1pPr marL="0" indent="0">
              <a:buNone/>
              <a:defRPr sz="756" b="1"/>
            </a:lvl1pPr>
            <a:lvl2pPr marL="143972" indent="0">
              <a:buNone/>
              <a:defRPr sz="630" b="1"/>
            </a:lvl2pPr>
            <a:lvl3pPr marL="287945" indent="0">
              <a:buNone/>
              <a:defRPr sz="567" b="1"/>
            </a:lvl3pPr>
            <a:lvl4pPr marL="431917" indent="0">
              <a:buNone/>
              <a:defRPr sz="504" b="1"/>
            </a:lvl4pPr>
            <a:lvl5pPr marL="575889" indent="0">
              <a:buNone/>
              <a:defRPr sz="504" b="1"/>
            </a:lvl5pPr>
            <a:lvl6pPr marL="719861" indent="0">
              <a:buNone/>
              <a:defRPr sz="504" b="1"/>
            </a:lvl6pPr>
            <a:lvl7pPr marL="863834" indent="0">
              <a:buNone/>
              <a:defRPr sz="504" b="1"/>
            </a:lvl7pPr>
            <a:lvl8pPr marL="1007806" indent="0">
              <a:buNone/>
              <a:defRPr sz="504" b="1"/>
            </a:lvl8pPr>
            <a:lvl9pPr marL="1151778" indent="0">
              <a:buNone/>
              <a:defRPr sz="504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57" y="1972167"/>
            <a:ext cx="1218258" cy="2900760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7861" y="1323527"/>
            <a:ext cx="1224258" cy="648640"/>
          </a:xfrm>
        </p:spPr>
        <p:txBody>
          <a:bodyPr anchor="b"/>
          <a:lstStyle>
            <a:lvl1pPr marL="0" indent="0">
              <a:buNone/>
              <a:defRPr sz="756" b="1"/>
            </a:lvl1pPr>
            <a:lvl2pPr marL="143972" indent="0">
              <a:buNone/>
              <a:defRPr sz="630" b="1"/>
            </a:lvl2pPr>
            <a:lvl3pPr marL="287945" indent="0">
              <a:buNone/>
              <a:defRPr sz="567" b="1"/>
            </a:lvl3pPr>
            <a:lvl4pPr marL="431917" indent="0">
              <a:buNone/>
              <a:defRPr sz="504" b="1"/>
            </a:lvl4pPr>
            <a:lvl5pPr marL="575889" indent="0">
              <a:buNone/>
              <a:defRPr sz="504" b="1"/>
            </a:lvl5pPr>
            <a:lvl6pPr marL="719861" indent="0">
              <a:buNone/>
              <a:defRPr sz="504" b="1"/>
            </a:lvl6pPr>
            <a:lvl7pPr marL="863834" indent="0">
              <a:buNone/>
              <a:defRPr sz="504" b="1"/>
            </a:lvl7pPr>
            <a:lvl8pPr marL="1007806" indent="0">
              <a:buNone/>
              <a:defRPr sz="504" b="1"/>
            </a:lvl8pPr>
            <a:lvl9pPr marL="1151778" indent="0">
              <a:buNone/>
              <a:defRPr sz="504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7861" y="1972167"/>
            <a:ext cx="1224258" cy="2900760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0570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860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8443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56" y="359939"/>
            <a:ext cx="928786" cy="1259787"/>
          </a:xfrm>
        </p:spPr>
        <p:txBody>
          <a:bodyPr anchor="b"/>
          <a:lstStyle>
            <a:lvl1pPr>
              <a:defRPr sz="1008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258" y="777370"/>
            <a:ext cx="1457861" cy="3836852"/>
          </a:xfrm>
        </p:spPr>
        <p:txBody>
          <a:bodyPr/>
          <a:lstStyle>
            <a:lvl1pPr>
              <a:defRPr sz="1008"/>
            </a:lvl1pPr>
            <a:lvl2pPr>
              <a:defRPr sz="882"/>
            </a:lvl2pPr>
            <a:lvl3pPr>
              <a:defRPr sz="756"/>
            </a:lvl3pPr>
            <a:lvl4pPr>
              <a:defRPr sz="630"/>
            </a:lvl4pPr>
            <a:lvl5pPr>
              <a:defRPr sz="630"/>
            </a:lvl5pPr>
            <a:lvl6pPr>
              <a:defRPr sz="630"/>
            </a:lvl6pPr>
            <a:lvl7pPr>
              <a:defRPr sz="630"/>
            </a:lvl7pPr>
            <a:lvl8pPr>
              <a:defRPr sz="630"/>
            </a:lvl8pPr>
            <a:lvl9pPr>
              <a:defRPr sz="63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56" y="1619726"/>
            <a:ext cx="928786" cy="3000744"/>
          </a:xfrm>
        </p:spPr>
        <p:txBody>
          <a:bodyPr/>
          <a:lstStyle>
            <a:lvl1pPr marL="0" indent="0">
              <a:buNone/>
              <a:defRPr sz="504"/>
            </a:lvl1pPr>
            <a:lvl2pPr marL="143972" indent="0">
              <a:buNone/>
              <a:defRPr sz="441"/>
            </a:lvl2pPr>
            <a:lvl3pPr marL="287945" indent="0">
              <a:buNone/>
              <a:defRPr sz="378"/>
            </a:lvl3pPr>
            <a:lvl4pPr marL="431917" indent="0">
              <a:buNone/>
              <a:defRPr sz="315"/>
            </a:lvl4pPr>
            <a:lvl5pPr marL="575889" indent="0">
              <a:buNone/>
              <a:defRPr sz="315"/>
            </a:lvl5pPr>
            <a:lvl6pPr marL="719861" indent="0">
              <a:buNone/>
              <a:defRPr sz="315"/>
            </a:lvl6pPr>
            <a:lvl7pPr marL="863834" indent="0">
              <a:buNone/>
              <a:defRPr sz="315"/>
            </a:lvl7pPr>
            <a:lvl8pPr marL="1007806" indent="0">
              <a:buNone/>
              <a:defRPr sz="315"/>
            </a:lvl8pPr>
            <a:lvl9pPr marL="1151778" indent="0">
              <a:buNone/>
              <a:defRPr sz="315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1723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56" y="359939"/>
            <a:ext cx="928786" cy="1259787"/>
          </a:xfrm>
        </p:spPr>
        <p:txBody>
          <a:bodyPr anchor="b"/>
          <a:lstStyle>
            <a:lvl1pPr>
              <a:defRPr sz="1008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258" y="777370"/>
            <a:ext cx="1457861" cy="3836852"/>
          </a:xfrm>
        </p:spPr>
        <p:txBody>
          <a:bodyPr anchor="t"/>
          <a:lstStyle>
            <a:lvl1pPr marL="0" indent="0">
              <a:buNone/>
              <a:defRPr sz="1008"/>
            </a:lvl1pPr>
            <a:lvl2pPr marL="143972" indent="0">
              <a:buNone/>
              <a:defRPr sz="882"/>
            </a:lvl2pPr>
            <a:lvl3pPr marL="287945" indent="0">
              <a:buNone/>
              <a:defRPr sz="756"/>
            </a:lvl3pPr>
            <a:lvl4pPr marL="431917" indent="0">
              <a:buNone/>
              <a:defRPr sz="630"/>
            </a:lvl4pPr>
            <a:lvl5pPr marL="575889" indent="0">
              <a:buNone/>
              <a:defRPr sz="630"/>
            </a:lvl5pPr>
            <a:lvl6pPr marL="719861" indent="0">
              <a:buNone/>
              <a:defRPr sz="630"/>
            </a:lvl6pPr>
            <a:lvl7pPr marL="863834" indent="0">
              <a:buNone/>
              <a:defRPr sz="630"/>
            </a:lvl7pPr>
            <a:lvl8pPr marL="1007806" indent="0">
              <a:buNone/>
              <a:defRPr sz="630"/>
            </a:lvl8pPr>
            <a:lvl9pPr marL="1151778" indent="0">
              <a:buNone/>
              <a:defRPr sz="63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56" y="1619726"/>
            <a:ext cx="928786" cy="3000744"/>
          </a:xfrm>
        </p:spPr>
        <p:txBody>
          <a:bodyPr/>
          <a:lstStyle>
            <a:lvl1pPr marL="0" indent="0">
              <a:buNone/>
              <a:defRPr sz="504"/>
            </a:lvl1pPr>
            <a:lvl2pPr marL="143972" indent="0">
              <a:buNone/>
              <a:defRPr sz="441"/>
            </a:lvl2pPr>
            <a:lvl3pPr marL="287945" indent="0">
              <a:buNone/>
              <a:defRPr sz="378"/>
            </a:lvl3pPr>
            <a:lvl4pPr marL="431917" indent="0">
              <a:buNone/>
              <a:defRPr sz="315"/>
            </a:lvl4pPr>
            <a:lvl5pPr marL="575889" indent="0">
              <a:buNone/>
              <a:defRPr sz="315"/>
            </a:lvl5pPr>
            <a:lvl6pPr marL="719861" indent="0">
              <a:buNone/>
              <a:defRPr sz="315"/>
            </a:lvl6pPr>
            <a:lvl7pPr marL="863834" indent="0">
              <a:buNone/>
              <a:defRPr sz="315"/>
            </a:lvl7pPr>
            <a:lvl8pPr marL="1007806" indent="0">
              <a:buNone/>
              <a:defRPr sz="315"/>
            </a:lvl8pPr>
            <a:lvl9pPr marL="1151778" indent="0">
              <a:buNone/>
              <a:defRPr sz="315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8614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7981" y="287453"/>
            <a:ext cx="2483763" cy="1043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7981" y="1437257"/>
            <a:ext cx="2483763" cy="34256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7981" y="5004156"/>
            <a:ext cx="647938" cy="2874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884C2-23B9-EA43-BF45-C4118BD2EABF}" type="datetimeFigureOut">
              <a:rPr lang="it-IT" smtClean="0"/>
              <a:t>18/07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3909" y="5004156"/>
            <a:ext cx="971907" cy="2874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3806" y="5004156"/>
            <a:ext cx="647938" cy="2874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5B0CEA-521C-7F42-86D3-CC79FDEE086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2426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87945" rtl="0" eaLnBrk="1" latinLnBrk="0" hangingPunct="1">
        <a:lnSpc>
          <a:spcPct val="90000"/>
        </a:lnSpc>
        <a:spcBef>
          <a:spcPct val="0"/>
        </a:spcBef>
        <a:buNone/>
        <a:defRPr sz="13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1986" indent="-71986" algn="l" defTabSz="287945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882" kern="1200">
          <a:solidFill>
            <a:schemeClr val="tx1"/>
          </a:solidFill>
          <a:latin typeface="+mn-lt"/>
          <a:ea typeface="+mn-ea"/>
          <a:cs typeface="+mn-cs"/>
        </a:defRPr>
      </a:lvl1pPr>
      <a:lvl2pPr marL="215958" indent="-71986" algn="l" defTabSz="287945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2pPr>
      <a:lvl3pPr marL="359931" indent="-71986" algn="l" defTabSz="287945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3pPr>
      <a:lvl4pPr marL="503903" indent="-71986" algn="l" defTabSz="287945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4pPr>
      <a:lvl5pPr marL="647875" indent="-71986" algn="l" defTabSz="287945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5pPr>
      <a:lvl6pPr marL="791848" indent="-71986" algn="l" defTabSz="287945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6pPr>
      <a:lvl7pPr marL="935820" indent="-71986" algn="l" defTabSz="287945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7pPr>
      <a:lvl8pPr marL="1079792" indent="-71986" algn="l" defTabSz="287945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8pPr>
      <a:lvl9pPr marL="1223764" indent="-71986" algn="l" defTabSz="287945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7945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1pPr>
      <a:lvl2pPr marL="143972" algn="l" defTabSz="287945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2pPr>
      <a:lvl3pPr marL="287945" algn="l" defTabSz="287945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3pPr>
      <a:lvl4pPr marL="431917" algn="l" defTabSz="287945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4pPr>
      <a:lvl5pPr marL="575889" algn="l" defTabSz="287945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5pPr>
      <a:lvl6pPr marL="719861" algn="l" defTabSz="287945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6pPr>
      <a:lvl7pPr marL="863834" algn="l" defTabSz="287945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7pPr>
      <a:lvl8pPr marL="1007806" algn="l" defTabSz="287945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8pPr>
      <a:lvl9pPr marL="1151778" algn="l" defTabSz="287945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>
            <a:extLst>
              <a:ext uri="{FF2B5EF4-FFF2-40B4-BE49-F238E27FC236}">
                <a16:creationId xmlns:a16="http://schemas.microsoft.com/office/drawing/2014/main" id="{D1CC7AAA-07DB-F646-9727-3745E3D42146}"/>
              </a:ext>
            </a:extLst>
          </p:cNvPr>
          <p:cNvSpPr/>
          <p:nvPr/>
        </p:nvSpPr>
        <p:spPr>
          <a:xfrm>
            <a:off x="34592" y="4631405"/>
            <a:ext cx="2666114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it-IT" sz="1000" b="1" dirty="0">
                <a:solidFill>
                  <a:srgbClr val="231F20"/>
                </a:solidFill>
                <a:latin typeface="Times New Roman" panose="02020603050405020304" pitchFamily="18" charset="0"/>
                <a:ea typeface="MS Minngs" charset="-128"/>
                <a:cs typeface="Times New Roman" panose="02020603050405020304" pitchFamily="18" charset="0"/>
              </a:rPr>
              <a:t>HLG - High level gentamicin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it-IT" sz="1000" b="1" dirty="0">
                <a:solidFill>
                  <a:srgbClr val="231F20"/>
                </a:solidFill>
                <a:latin typeface="Times New Roman" panose="02020603050405020304" pitchFamily="18" charset="0"/>
                <a:ea typeface="MS Minngs" charset="-128"/>
                <a:cs typeface="Times New Roman" panose="02020603050405020304" pitchFamily="18" charset="0"/>
              </a:rPr>
              <a:t>HLS - High level streptomycin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it-IT" sz="1000" b="1" dirty="0">
                <a:solidFill>
                  <a:srgbClr val="231F20"/>
                </a:solidFill>
                <a:latin typeface="Times New Roman" panose="02020603050405020304" pitchFamily="18" charset="0"/>
                <a:ea typeface="MS Minngs" charset="-128"/>
                <a:cs typeface="Times New Roman" panose="02020603050405020304" pitchFamily="18" charset="0"/>
              </a:rPr>
              <a:t>TXP/SMX - Trimethoprim/Sulfamethoxazole</a:t>
            </a:r>
            <a:endParaRPr lang="en-GB" altLang="it-IT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graphicFrame>
        <p:nvGraphicFramePr>
          <p:cNvPr id="7" name="Tabella 6">
            <a:extLst>
              <a:ext uri="{FF2B5EF4-FFF2-40B4-BE49-F238E27FC236}">
                <a16:creationId xmlns:a16="http://schemas.microsoft.com/office/drawing/2014/main" id="{C2C5D67A-C9EA-2042-BD85-3E991C0FFB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1605762"/>
              </p:ext>
            </p:extLst>
          </p:nvPr>
        </p:nvGraphicFramePr>
        <p:xfrm>
          <a:off x="111357" y="107780"/>
          <a:ext cx="2699788" cy="4377901"/>
        </p:xfrm>
        <a:graphic>
          <a:graphicData uri="http://schemas.openxmlformats.org/drawingml/2006/table">
            <a:tbl>
              <a:tblPr/>
              <a:tblGrid>
                <a:gridCol w="1598063">
                  <a:extLst>
                    <a:ext uri="{9D8B030D-6E8A-4147-A177-3AD203B41FA5}">
                      <a16:colId xmlns:a16="http://schemas.microsoft.com/office/drawing/2014/main" val="2695647545"/>
                    </a:ext>
                  </a:extLst>
                </a:gridCol>
                <a:gridCol w="1101725">
                  <a:extLst>
                    <a:ext uri="{9D8B030D-6E8A-4147-A177-3AD203B41FA5}">
                      <a16:colId xmlns:a16="http://schemas.microsoft.com/office/drawing/2014/main" val="2123472003"/>
                    </a:ext>
                  </a:extLst>
                </a:gridCol>
              </a:tblGrid>
              <a:tr h="498693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iotic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noProof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. Range (</a:t>
                      </a:r>
                      <a:r>
                        <a:rPr lang="en-GB" sz="1200" b="1" noProof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g</a:t>
                      </a:r>
                      <a:r>
                        <a:rPr lang="en-GB" sz="1200" b="1" noProof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lang="en-GB" sz="1200" b="1" noProof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3907718"/>
                  </a:ext>
                </a:extLst>
              </a:tr>
              <a:tr h="18578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icill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8 - 2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7900648"/>
                  </a:ext>
                </a:extLst>
              </a:tr>
              <a:tr h="18578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icillin/Sulbactam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/1 – 8/4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8579610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zilpenicill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259973"/>
                  </a:ext>
                </a:extLst>
              </a:tr>
              <a:tr h="18578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fotaxime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 - 4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1346834"/>
                  </a:ext>
                </a:extLst>
              </a:tr>
              <a:tr h="18578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ftriaxone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 - 4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7901126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ndamyc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5 - 1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9795312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ptomyc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-25 - 4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7575542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ythromyc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- 4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1735377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idic Acid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5 - 1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6917527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tamic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5 - 4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5392099"/>
                  </a:ext>
                </a:extLst>
              </a:tr>
              <a:tr h="18578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G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2527921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ofloxac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5 - 4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13078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zolid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7263761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xacill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 - 2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4397369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fampic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25 - 2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0791705"/>
                  </a:ext>
                </a:extLst>
              </a:tr>
              <a:tr h="18578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S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2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1577901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icoplan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 - 4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8251065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gecycl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25 - 0.5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316424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P/SMX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/4.75 - 4/76</a:t>
                      </a:r>
                      <a:endParaRPr lang="en-GB" sz="1200" noProof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2372489"/>
                  </a:ext>
                </a:extLst>
              </a:tr>
              <a:tr h="195566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2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ncomycin</a:t>
                      </a:r>
                    </a:p>
                  </a:txBody>
                  <a:tcPr marL="7334" marR="7334" marT="73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noProof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 - 4</a:t>
                      </a:r>
                      <a:endParaRPr lang="en-GB" sz="1200" noProof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ngs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82369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412519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03</Words>
  <Application>Microsoft Macintosh PowerPoint</Application>
  <PresentationFormat>Personalizzato</PresentationFormat>
  <Paragraphs>4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ngs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nea gino di domenico</dc:creator>
  <cp:lastModifiedBy>enea gino di domenico</cp:lastModifiedBy>
  <cp:revision>1</cp:revision>
  <dcterms:created xsi:type="dcterms:W3CDTF">2019-07-18T13:39:12Z</dcterms:created>
  <dcterms:modified xsi:type="dcterms:W3CDTF">2019-07-18T13:41:14Z</dcterms:modified>
</cp:coreProperties>
</file>